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7" r:id="rId2"/>
  </p:sldIdLst>
  <p:sldSz cx="7315200" cy="9321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54CFF"/>
    <a:srgbClr val="00B5FF"/>
    <a:srgbClr val="A20305"/>
    <a:srgbClr val="A303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857"/>
    <p:restoredTop sz="95551"/>
  </p:normalViewPr>
  <p:slideViewPr>
    <p:cSldViewPr snapToGrid="0" snapToObjects="1">
      <p:cViewPr varScale="1">
        <p:scale>
          <a:sx n="80" d="100"/>
          <a:sy n="80" d="100"/>
        </p:scale>
        <p:origin x="260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F5A565-0660-F24A-9241-43E2B99AF08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143000"/>
            <a:ext cx="2422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1F7975-6509-8042-909C-D5380521D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710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E1F7975-6509-8042-909C-D5380521D34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1073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525583"/>
            <a:ext cx="6217920" cy="32453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96103"/>
            <a:ext cx="5486400" cy="2250610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741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232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96299"/>
            <a:ext cx="1577340" cy="789979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96299"/>
            <a:ext cx="4640580" cy="789979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221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493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323979"/>
            <a:ext cx="6309360" cy="387760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238272"/>
            <a:ext cx="6309360" cy="2039143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228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569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96301"/>
            <a:ext cx="6309360" cy="18017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85136"/>
            <a:ext cx="3094672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405047"/>
            <a:ext cx="3094672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85136"/>
            <a:ext cx="3109913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405047"/>
            <a:ext cx="3109913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471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593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97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42169"/>
            <a:ext cx="3703320" cy="6624520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7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42169"/>
            <a:ext cx="3703320" cy="6624520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378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96301"/>
            <a:ext cx="6309360" cy="18017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81498"/>
            <a:ext cx="6309360" cy="59145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639929"/>
            <a:ext cx="246888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951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19" Type="http://schemas.openxmlformats.org/officeDocument/2006/relationships/image" Target="../media/image17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itle 1">
            <a:extLst>
              <a:ext uri="{FF2B5EF4-FFF2-40B4-BE49-F238E27FC236}">
                <a16:creationId xmlns:a16="http://schemas.microsoft.com/office/drawing/2014/main" id="{D3B1ED3B-CB2D-7848-9AFC-3468B03660C1}"/>
              </a:ext>
            </a:extLst>
          </p:cNvPr>
          <p:cNvSpPr txBox="1">
            <a:spLocks/>
          </p:cNvSpPr>
          <p:nvPr/>
        </p:nvSpPr>
        <p:spPr>
          <a:xfrm>
            <a:off x="-34290" y="7072"/>
            <a:ext cx="3000375" cy="376845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6B7E29C-E21E-1E49-8F1E-203CE14B0D03}"/>
              </a:ext>
            </a:extLst>
          </p:cNvPr>
          <p:cNvSpPr txBox="1"/>
          <p:nvPr/>
        </p:nvSpPr>
        <p:spPr>
          <a:xfrm>
            <a:off x="523665" y="260117"/>
            <a:ext cx="8732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/>
              <a:t>TH2</a:t>
            </a:r>
          </a:p>
          <a:p>
            <a:pPr algn="ctr"/>
            <a:r>
              <a:rPr lang="en-US" sz="1000" b="1" i="1" u="sng" dirty="0"/>
              <a:t>(GATA3+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334C099-FDBD-DE45-BA50-15E47025A9AB}"/>
              </a:ext>
            </a:extLst>
          </p:cNvPr>
          <p:cNvSpPr txBox="1"/>
          <p:nvPr/>
        </p:nvSpPr>
        <p:spPr>
          <a:xfrm>
            <a:off x="2262276" y="216012"/>
            <a:ext cx="8732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/>
              <a:t>TH2</a:t>
            </a:r>
          </a:p>
          <a:p>
            <a:pPr algn="ctr"/>
            <a:r>
              <a:rPr lang="en-US" sz="1000" b="1" i="1" u="sng" dirty="0"/>
              <a:t>(IL-4+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EAD06EB-5888-A14B-8AA6-723DFD0C19F8}"/>
              </a:ext>
            </a:extLst>
          </p:cNvPr>
          <p:cNvSpPr txBox="1"/>
          <p:nvPr/>
        </p:nvSpPr>
        <p:spPr>
          <a:xfrm>
            <a:off x="6001863" y="155556"/>
            <a:ext cx="8732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/>
              <a:t>TH17</a:t>
            </a:r>
          </a:p>
          <a:p>
            <a:pPr algn="ctr"/>
            <a:r>
              <a:rPr lang="en-US" sz="1000" b="1" i="1" u="sng" dirty="0"/>
              <a:t>(IL17A+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FB6498C-7D59-084D-823B-237E5E29FDE4}"/>
              </a:ext>
            </a:extLst>
          </p:cNvPr>
          <p:cNvSpPr txBox="1"/>
          <p:nvPr/>
        </p:nvSpPr>
        <p:spPr>
          <a:xfrm>
            <a:off x="4005072" y="213552"/>
            <a:ext cx="8732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/>
              <a:t>TH17</a:t>
            </a:r>
          </a:p>
          <a:p>
            <a:pPr algn="ctr"/>
            <a:r>
              <a:rPr lang="en-US" sz="1000" b="1" i="1" u="sng" dirty="0"/>
              <a:t>(</a:t>
            </a:r>
            <a:r>
              <a:rPr lang="en-US" sz="1000" b="1" i="1" u="sng" dirty="0" err="1"/>
              <a:t>RORgt</a:t>
            </a:r>
            <a:r>
              <a:rPr lang="en-US" sz="1000" b="1" i="1" u="sng" dirty="0"/>
              <a:t>+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0955625-AB5E-6D41-AB73-094793D6CF43}"/>
              </a:ext>
            </a:extLst>
          </p:cNvPr>
          <p:cNvSpPr txBox="1"/>
          <p:nvPr/>
        </p:nvSpPr>
        <p:spPr>
          <a:xfrm>
            <a:off x="280825" y="1928023"/>
            <a:ext cx="14495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/>
              <a:t>Tregs</a:t>
            </a:r>
          </a:p>
          <a:p>
            <a:pPr algn="ctr"/>
            <a:r>
              <a:rPr lang="en-US" sz="1000" b="1" i="1" u="sng" dirty="0"/>
              <a:t>(FOXP3+ CD25+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827594F-BC7B-394F-90D9-263311B237FD}"/>
              </a:ext>
            </a:extLst>
          </p:cNvPr>
          <p:cNvSpPr txBox="1"/>
          <p:nvPr/>
        </p:nvSpPr>
        <p:spPr>
          <a:xfrm>
            <a:off x="2020591" y="1888684"/>
            <a:ext cx="14495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 err="1"/>
              <a:t>Tfh</a:t>
            </a:r>
            <a:endParaRPr lang="en-US" sz="1000" b="1" i="1" u="sng" dirty="0"/>
          </a:p>
          <a:p>
            <a:pPr algn="ctr"/>
            <a:r>
              <a:rPr lang="en-US" sz="1000" b="1" i="1" u="sng" dirty="0"/>
              <a:t>(CXCR5+ BCL6+)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1640FB68-DF9B-DE42-A425-E460CEC73C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384" y="558874"/>
            <a:ext cx="1623319" cy="1224034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B3465409-92CF-D042-B954-0FA867F488B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63175" y="593205"/>
            <a:ext cx="1652388" cy="1202321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5FA95C9C-0BBC-814A-87D2-EC08CB9B088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93822" y="556103"/>
            <a:ext cx="1703378" cy="1239423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E9C6CD15-F86A-CB47-975B-DE712D8AACD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82919" y="495044"/>
            <a:ext cx="1764276" cy="1283734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4938D375-6DAB-E54E-AED7-BA74D40847D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814" y="2398595"/>
            <a:ext cx="1639254" cy="1192764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1D15BD3C-3895-7244-B970-49A79259830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63175" y="2321092"/>
            <a:ext cx="1755570" cy="1323756"/>
          </a:xfrm>
          <a:prstGeom prst="rect">
            <a:avLst/>
          </a:prstGeom>
        </p:spPr>
      </p:pic>
      <p:sp>
        <p:nvSpPr>
          <p:cNvPr id="40" name="TextBox 4">
            <a:extLst>
              <a:ext uri="{FF2B5EF4-FFF2-40B4-BE49-F238E27FC236}">
                <a16:creationId xmlns:a16="http://schemas.microsoft.com/office/drawing/2014/main" id="{C81DC9C4-A849-7B46-BAE2-37B603B80A6A}"/>
              </a:ext>
            </a:extLst>
          </p:cNvPr>
          <p:cNvSpPr txBox="1"/>
          <p:nvPr/>
        </p:nvSpPr>
        <p:spPr>
          <a:xfrm>
            <a:off x="117624" y="3683842"/>
            <a:ext cx="1671637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i="1" u="sng" dirty="0">
                <a:ea typeface="Calibri"/>
                <a:cs typeface="Calibri"/>
              </a:rPr>
              <a:t>TNF-a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49769AB7-763A-AF43-984B-5A0647A62F7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0211" y="3944473"/>
            <a:ext cx="1846461" cy="1343534"/>
          </a:xfrm>
          <a:prstGeom prst="rect">
            <a:avLst/>
          </a:prstGeom>
        </p:spPr>
      </p:pic>
      <p:sp>
        <p:nvSpPr>
          <p:cNvPr id="50" name="TextBox 33">
            <a:extLst>
              <a:ext uri="{FF2B5EF4-FFF2-40B4-BE49-F238E27FC236}">
                <a16:creationId xmlns:a16="http://schemas.microsoft.com/office/drawing/2014/main" id="{FB40090B-90C0-E84D-93C9-577B783C28CB}"/>
              </a:ext>
            </a:extLst>
          </p:cNvPr>
          <p:cNvSpPr txBox="1"/>
          <p:nvPr/>
        </p:nvSpPr>
        <p:spPr>
          <a:xfrm>
            <a:off x="3751903" y="1888684"/>
            <a:ext cx="14495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i="1" u="sng" dirty="0"/>
              <a:t>T-</a:t>
            </a:r>
            <a:r>
              <a:rPr lang="en-US" sz="1000" b="1" i="1" u="sng" dirty="0" err="1"/>
              <a:t>cytotox</a:t>
            </a:r>
            <a:endParaRPr lang="en-US" sz="1000" b="1" i="1" u="sng" dirty="0"/>
          </a:p>
          <a:p>
            <a:pPr algn="ctr"/>
            <a:r>
              <a:rPr lang="en-US" sz="1000" b="1" i="1" u="sng" dirty="0"/>
              <a:t>(Granzyme a)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C3003C44-88BA-CA40-97B8-F9B897B6EAB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49017" y="2275199"/>
            <a:ext cx="1819279" cy="1323756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97430EF9-0E77-374D-955E-60C4803104F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381738" y="2250307"/>
            <a:ext cx="1765457" cy="1325865"/>
          </a:xfrm>
          <a:prstGeom prst="rect">
            <a:avLst/>
          </a:prstGeom>
        </p:spPr>
      </p:pic>
      <p:sp>
        <p:nvSpPr>
          <p:cNvPr id="53" name="TextBox 38">
            <a:extLst>
              <a:ext uri="{FF2B5EF4-FFF2-40B4-BE49-F238E27FC236}">
                <a16:creationId xmlns:a16="http://schemas.microsoft.com/office/drawing/2014/main" id="{64CE439A-08A5-014F-9C8D-C45FF21C563F}"/>
              </a:ext>
            </a:extLst>
          </p:cNvPr>
          <p:cNvSpPr txBox="1"/>
          <p:nvPr/>
        </p:nvSpPr>
        <p:spPr>
          <a:xfrm>
            <a:off x="5680245" y="1871307"/>
            <a:ext cx="14495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i="1" u="sng" dirty="0"/>
              <a:t>T-</a:t>
            </a:r>
            <a:r>
              <a:rPr lang="en-US" sz="1000" b="1" i="1" u="sng" dirty="0" err="1"/>
              <a:t>cytotox</a:t>
            </a:r>
            <a:endParaRPr lang="en-US" sz="1000" b="1" i="1" u="sng" dirty="0"/>
          </a:p>
          <a:p>
            <a:pPr algn="ctr"/>
            <a:r>
              <a:rPr lang="en-US" sz="1000" b="1" i="1" u="sng" dirty="0"/>
              <a:t>(Granzyme b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D50F4D2-780A-334D-A488-FD899149654F}"/>
              </a:ext>
            </a:extLst>
          </p:cNvPr>
          <p:cNvSpPr txBox="1"/>
          <p:nvPr/>
        </p:nvSpPr>
        <p:spPr>
          <a:xfrm>
            <a:off x="24319" y="235390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A.</a:t>
            </a:r>
            <a:endParaRPr lang="en-US" b="1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8724413-D775-6249-AE6D-DCC20355D6F5}"/>
              </a:ext>
            </a:extLst>
          </p:cNvPr>
          <p:cNvSpPr txBox="1"/>
          <p:nvPr/>
        </p:nvSpPr>
        <p:spPr>
          <a:xfrm>
            <a:off x="3450390" y="179324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C.</a:t>
            </a:r>
            <a:endParaRPr lang="en-US" b="1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5895F09-8281-244F-BD93-227A742DA41C}"/>
              </a:ext>
            </a:extLst>
          </p:cNvPr>
          <p:cNvSpPr txBox="1"/>
          <p:nvPr/>
        </p:nvSpPr>
        <p:spPr>
          <a:xfrm>
            <a:off x="1781299" y="200934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B.</a:t>
            </a:r>
            <a:endParaRPr lang="en-US" b="1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29EBD18-FE14-014D-A8F8-295F4F9D03F4}"/>
              </a:ext>
            </a:extLst>
          </p:cNvPr>
          <p:cNvSpPr txBox="1"/>
          <p:nvPr/>
        </p:nvSpPr>
        <p:spPr>
          <a:xfrm>
            <a:off x="5250031" y="155556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D.</a:t>
            </a:r>
            <a:endParaRPr lang="en-US" b="1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A04F67E-4FE7-2544-9379-5CD97888154D}"/>
              </a:ext>
            </a:extLst>
          </p:cNvPr>
          <p:cNvSpPr txBox="1"/>
          <p:nvPr/>
        </p:nvSpPr>
        <p:spPr>
          <a:xfrm>
            <a:off x="0" y="1902443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E.</a:t>
            </a:r>
            <a:endParaRPr lang="en-US" b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0C47943-5BD1-1C49-866F-6EB2CF4BA97D}"/>
              </a:ext>
            </a:extLst>
          </p:cNvPr>
          <p:cNvSpPr txBox="1"/>
          <p:nvPr/>
        </p:nvSpPr>
        <p:spPr>
          <a:xfrm>
            <a:off x="1781299" y="1867605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F.</a:t>
            </a:r>
            <a:endParaRPr lang="en-US" b="1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B429FB1-B63B-E746-8A0B-B00C85D81C82}"/>
              </a:ext>
            </a:extLst>
          </p:cNvPr>
          <p:cNvSpPr txBox="1"/>
          <p:nvPr/>
        </p:nvSpPr>
        <p:spPr>
          <a:xfrm>
            <a:off x="3512834" y="1869400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G.</a:t>
            </a:r>
            <a:endParaRPr lang="en-US" b="1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600CC92-06D0-6A46-A21A-F80A31A57E35}"/>
              </a:ext>
            </a:extLst>
          </p:cNvPr>
          <p:cNvSpPr txBox="1"/>
          <p:nvPr/>
        </p:nvSpPr>
        <p:spPr>
          <a:xfrm>
            <a:off x="5343479" y="1841811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H.</a:t>
            </a:r>
            <a:endParaRPr lang="en-US" b="1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569AE25-DE5C-984A-85C9-C8401228A776}"/>
              </a:ext>
            </a:extLst>
          </p:cNvPr>
          <p:cNvSpPr txBox="1"/>
          <p:nvPr/>
        </p:nvSpPr>
        <p:spPr>
          <a:xfrm>
            <a:off x="0" y="3653873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I.</a:t>
            </a:r>
            <a:endParaRPr lang="en-US" b="1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4BB8774-79C8-9F47-8F5D-F3302D371D51}"/>
              </a:ext>
            </a:extLst>
          </p:cNvPr>
          <p:cNvSpPr txBox="1"/>
          <p:nvPr/>
        </p:nvSpPr>
        <p:spPr>
          <a:xfrm>
            <a:off x="1928400" y="3622287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J.</a:t>
            </a:r>
            <a:endParaRPr lang="en-US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8B25BD8-3C13-814F-91B4-B43EA7016801}"/>
              </a:ext>
            </a:extLst>
          </p:cNvPr>
          <p:cNvSpPr txBox="1"/>
          <p:nvPr/>
        </p:nvSpPr>
        <p:spPr>
          <a:xfrm>
            <a:off x="3538824" y="3602278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K.</a:t>
            </a:r>
            <a:endParaRPr lang="en-US" b="1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19DE449-0C6D-CE46-8F8B-11BFE717ECED}"/>
              </a:ext>
            </a:extLst>
          </p:cNvPr>
          <p:cNvSpPr txBox="1"/>
          <p:nvPr/>
        </p:nvSpPr>
        <p:spPr>
          <a:xfrm>
            <a:off x="5346124" y="3582178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L.</a:t>
            </a:r>
            <a:endParaRPr lang="en-US" b="1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2A14FFC-962F-1B48-AA4F-0DF1F4FA16C4}"/>
              </a:ext>
            </a:extLst>
          </p:cNvPr>
          <p:cNvSpPr txBox="1"/>
          <p:nvPr/>
        </p:nvSpPr>
        <p:spPr>
          <a:xfrm>
            <a:off x="0" y="5503743"/>
            <a:ext cx="45501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M.</a:t>
            </a:r>
            <a:endParaRPr lang="en-US" b="1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31D18F1-ADD1-A040-B7EC-31B3E1BEA2B9}"/>
              </a:ext>
            </a:extLst>
          </p:cNvPr>
          <p:cNvSpPr txBox="1"/>
          <p:nvPr/>
        </p:nvSpPr>
        <p:spPr>
          <a:xfrm>
            <a:off x="1900048" y="5503743"/>
            <a:ext cx="45501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N.</a:t>
            </a:r>
            <a:endParaRPr lang="en-US" b="1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ACBFD89-7DB1-7A42-B028-4873AEA17ABB}"/>
              </a:ext>
            </a:extLst>
          </p:cNvPr>
          <p:cNvSpPr txBox="1"/>
          <p:nvPr/>
        </p:nvSpPr>
        <p:spPr>
          <a:xfrm>
            <a:off x="3547822" y="5503743"/>
            <a:ext cx="45501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O.</a:t>
            </a:r>
            <a:endParaRPr lang="en-US" b="1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2C4681E-D3CE-D64B-AD13-105332D92A8E}"/>
              </a:ext>
            </a:extLst>
          </p:cNvPr>
          <p:cNvSpPr txBox="1"/>
          <p:nvPr/>
        </p:nvSpPr>
        <p:spPr>
          <a:xfrm>
            <a:off x="5394187" y="5503743"/>
            <a:ext cx="45501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P.</a:t>
            </a:r>
            <a:endParaRPr lang="en-US" b="1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717CB6A-5273-0948-821A-7F51ADB8F634}"/>
              </a:ext>
            </a:extLst>
          </p:cNvPr>
          <p:cNvSpPr txBox="1"/>
          <p:nvPr/>
        </p:nvSpPr>
        <p:spPr>
          <a:xfrm>
            <a:off x="-29370" y="7238619"/>
            <a:ext cx="45501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Q.</a:t>
            </a:r>
            <a:endParaRPr lang="en-US" b="1" dirty="0"/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4A801064-8589-5642-92DF-0A57F0F624A2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4439" t="16935" r="1833" b="55527"/>
          <a:stretch/>
        </p:blipFill>
        <p:spPr>
          <a:xfrm>
            <a:off x="1152130" y="7708984"/>
            <a:ext cx="810255" cy="548113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5BBB4561-BD90-0A48-9A7B-533C19B3E9CB}"/>
              </a:ext>
            </a:extLst>
          </p:cNvPr>
          <p:cNvSpPr txBox="1"/>
          <p:nvPr/>
        </p:nvSpPr>
        <p:spPr>
          <a:xfrm>
            <a:off x="2358996" y="3656633"/>
            <a:ext cx="8732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/>
              <a:t>TH2</a:t>
            </a:r>
          </a:p>
          <a:p>
            <a:pPr algn="ctr"/>
            <a:r>
              <a:rPr lang="en-US" sz="1000" b="1" i="1" u="sng" dirty="0"/>
              <a:t>(GATA3+)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F91A1A6-C4D8-E248-806D-DEBA2DB9EA2B}"/>
              </a:ext>
            </a:extLst>
          </p:cNvPr>
          <p:cNvSpPr txBox="1"/>
          <p:nvPr/>
        </p:nvSpPr>
        <p:spPr>
          <a:xfrm>
            <a:off x="4097607" y="3612528"/>
            <a:ext cx="8732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/>
              <a:t>TH2</a:t>
            </a:r>
          </a:p>
          <a:p>
            <a:pPr algn="ctr"/>
            <a:r>
              <a:rPr lang="en-US" sz="1000" b="1" i="1" u="sng" dirty="0"/>
              <a:t>(IL-4+)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EB713C7-7DEA-3144-8D98-6CE4304621A7}"/>
              </a:ext>
            </a:extLst>
          </p:cNvPr>
          <p:cNvSpPr txBox="1"/>
          <p:nvPr/>
        </p:nvSpPr>
        <p:spPr>
          <a:xfrm>
            <a:off x="540185" y="5505470"/>
            <a:ext cx="8732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/>
              <a:t>TH17</a:t>
            </a:r>
          </a:p>
          <a:p>
            <a:pPr algn="ctr"/>
            <a:r>
              <a:rPr lang="en-US" sz="1000" b="1" i="1" u="sng" dirty="0"/>
              <a:t>(IL17A+)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BBC59F2-E96D-8743-8100-9FEDC079B84A}"/>
              </a:ext>
            </a:extLst>
          </p:cNvPr>
          <p:cNvSpPr txBox="1"/>
          <p:nvPr/>
        </p:nvSpPr>
        <p:spPr>
          <a:xfrm>
            <a:off x="5998070" y="3632509"/>
            <a:ext cx="8732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/>
              <a:t>TH17</a:t>
            </a:r>
          </a:p>
          <a:p>
            <a:pPr algn="r"/>
            <a:r>
              <a:rPr lang="en-US" sz="1000" b="1" i="1" u="sng" dirty="0"/>
              <a:t>(</a:t>
            </a:r>
            <a:r>
              <a:rPr lang="en-US" sz="1000" b="1" i="1" u="sng" dirty="0" err="1"/>
              <a:t>RORgt</a:t>
            </a:r>
            <a:r>
              <a:rPr lang="en-US" sz="1000" b="1" i="1" u="sng" dirty="0"/>
              <a:t>+)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D6B826D-C517-D243-8F5C-A6C3C3BAAAD2}"/>
              </a:ext>
            </a:extLst>
          </p:cNvPr>
          <p:cNvSpPr txBox="1"/>
          <p:nvPr/>
        </p:nvSpPr>
        <p:spPr>
          <a:xfrm>
            <a:off x="2198702" y="5481019"/>
            <a:ext cx="14495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/>
              <a:t>Tregs</a:t>
            </a:r>
          </a:p>
          <a:p>
            <a:pPr algn="ctr"/>
            <a:r>
              <a:rPr lang="en-US" sz="1000" b="1" i="1" u="sng" dirty="0"/>
              <a:t>(FOXP3+ CD25+)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A891B68-86A6-BA4D-8A6C-70AC9244CE3F}"/>
              </a:ext>
            </a:extLst>
          </p:cNvPr>
          <p:cNvSpPr txBox="1"/>
          <p:nvPr/>
        </p:nvSpPr>
        <p:spPr>
          <a:xfrm>
            <a:off x="3938476" y="5488354"/>
            <a:ext cx="14495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 err="1"/>
              <a:t>Tfh</a:t>
            </a:r>
            <a:endParaRPr lang="en-US" sz="1000" b="1" i="1" u="sng" dirty="0"/>
          </a:p>
          <a:p>
            <a:pPr algn="ctr"/>
            <a:r>
              <a:rPr lang="en-US" sz="1000" b="1" i="1" u="sng" dirty="0"/>
              <a:t>(BCL6+)</a:t>
            </a:r>
          </a:p>
        </p:txBody>
      </p:sp>
      <p:sp>
        <p:nvSpPr>
          <p:cNvPr id="68" name="TextBox 33">
            <a:extLst>
              <a:ext uri="{FF2B5EF4-FFF2-40B4-BE49-F238E27FC236}">
                <a16:creationId xmlns:a16="http://schemas.microsoft.com/office/drawing/2014/main" id="{40301497-7F64-B540-ACB4-6CD4864E24EE}"/>
              </a:ext>
            </a:extLst>
          </p:cNvPr>
          <p:cNvSpPr txBox="1"/>
          <p:nvPr/>
        </p:nvSpPr>
        <p:spPr>
          <a:xfrm>
            <a:off x="5779573" y="5480660"/>
            <a:ext cx="14495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i="1" u="sng" dirty="0"/>
              <a:t>T-</a:t>
            </a:r>
            <a:r>
              <a:rPr lang="en-US" sz="1000" b="1" i="1" u="sng" dirty="0" err="1"/>
              <a:t>cytotox</a:t>
            </a:r>
            <a:endParaRPr lang="en-US" sz="1000" b="1" i="1" u="sng" dirty="0"/>
          </a:p>
          <a:p>
            <a:pPr algn="ctr"/>
            <a:r>
              <a:rPr lang="en-US" sz="1000" b="1" i="1" u="sng" dirty="0"/>
              <a:t>(Granzyme a)</a:t>
            </a:r>
          </a:p>
        </p:txBody>
      </p:sp>
      <p:sp>
        <p:nvSpPr>
          <p:cNvPr id="69" name="TextBox 38">
            <a:extLst>
              <a:ext uri="{FF2B5EF4-FFF2-40B4-BE49-F238E27FC236}">
                <a16:creationId xmlns:a16="http://schemas.microsoft.com/office/drawing/2014/main" id="{1868DACB-1189-3748-AC7A-0C746B14045C}"/>
              </a:ext>
            </a:extLst>
          </p:cNvPr>
          <p:cNvSpPr txBox="1"/>
          <p:nvPr/>
        </p:nvSpPr>
        <p:spPr>
          <a:xfrm>
            <a:off x="280825" y="7285508"/>
            <a:ext cx="14495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i="1" u="sng" dirty="0"/>
              <a:t>T-</a:t>
            </a:r>
            <a:r>
              <a:rPr lang="en-US" sz="1000" b="1" i="1" u="sng" dirty="0" err="1"/>
              <a:t>cytotox</a:t>
            </a:r>
            <a:endParaRPr lang="en-US" sz="1000" b="1" i="1" u="sng" dirty="0"/>
          </a:p>
          <a:p>
            <a:pPr algn="ctr"/>
            <a:r>
              <a:rPr lang="en-US" sz="1000" b="1" i="1" u="sng" dirty="0"/>
              <a:t>(Granzyme b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76834FF-C956-B349-82BC-914CA969F981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12740" r="28717"/>
          <a:stretch/>
        </p:blipFill>
        <p:spPr>
          <a:xfrm>
            <a:off x="1828618" y="3970060"/>
            <a:ext cx="1694284" cy="130631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69E432E-8F02-E540-9D95-D5996099781F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13821" r="25429"/>
          <a:stretch/>
        </p:blipFill>
        <p:spPr>
          <a:xfrm>
            <a:off x="3564471" y="4023163"/>
            <a:ext cx="1658060" cy="125560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860816E-D784-B64E-A2A0-266E58342305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t="11199" r="25734"/>
          <a:stretch/>
        </p:blipFill>
        <p:spPr>
          <a:xfrm>
            <a:off x="5343479" y="3986092"/>
            <a:ext cx="1676312" cy="130937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73D5676-DEA2-484E-A15C-A8ED885DA9CF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t="12845" r="25869"/>
          <a:stretch/>
        </p:blipFill>
        <p:spPr>
          <a:xfrm>
            <a:off x="61246" y="5950401"/>
            <a:ext cx="1606872" cy="123793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8A3A8FF-E598-B745-AFE5-33B814E25D47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t="14604" r="28064"/>
          <a:stretch/>
        </p:blipFill>
        <p:spPr>
          <a:xfrm>
            <a:off x="1822499" y="5950401"/>
            <a:ext cx="1582800" cy="123125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F875809-AC9F-B543-94B0-AA5C18369AF6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t="14347" r="25404"/>
          <a:stretch/>
        </p:blipFill>
        <p:spPr>
          <a:xfrm>
            <a:off x="3570226" y="5950401"/>
            <a:ext cx="1698070" cy="127765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9F045D4-16D3-D843-8429-DDB4F6877405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t="15165" r="21718"/>
          <a:stretch/>
        </p:blipFill>
        <p:spPr>
          <a:xfrm>
            <a:off x="5342195" y="5953088"/>
            <a:ext cx="1805000" cy="128179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4904390-898D-A847-8DAB-F0CA4272394E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t="12767" r="28040"/>
          <a:stretch/>
        </p:blipFill>
        <p:spPr>
          <a:xfrm>
            <a:off x="48143" y="7730294"/>
            <a:ext cx="1598907" cy="1270104"/>
          </a:xfrm>
          <a:prstGeom prst="rect">
            <a:avLst/>
          </a:prstGeom>
        </p:spPr>
      </p:pic>
      <p:sp>
        <p:nvSpPr>
          <p:cNvPr id="70" name="TextBox 69">
            <a:extLst>
              <a:ext uri="{FF2B5EF4-FFF2-40B4-BE49-F238E27FC236}">
                <a16:creationId xmlns:a16="http://schemas.microsoft.com/office/drawing/2014/main" id="{7EF95577-4782-3648-A95E-83E9261D967C}"/>
              </a:ext>
            </a:extLst>
          </p:cNvPr>
          <p:cNvSpPr txBox="1"/>
          <p:nvPr/>
        </p:nvSpPr>
        <p:spPr>
          <a:xfrm>
            <a:off x="1994119" y="7267644"/>
            <a:ext cx="5231801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i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upplementary Figure S4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: Presence of CD4</a:t>
            </a:r>
            <a:r>
              <a:rPr lang="en-US" sz="1000" b="1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helper subsets in responders and non-responders.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nail</a:t>
            </a:r>
            <a:r>
              <a:rPr lang="en-US" sz="1000" baseline="30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I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qM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and sgCD73 tumors that were untreated or treated with anti-CTLA4 were analyzed by flow cytometry for the indicated immune cell populations after gating on CD45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cells followed by CD3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 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T-cells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</a:t>
            </a:r>
            <a:r>
              <a:rPr lang="en-US" sz="1000" baseline="-25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2, % of 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GATA3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B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</a:t>
            </a:r>
            <a:r>
              <a:rPr lang="en-US" sz="1000" baseline="-25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2, % of 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IL-4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</a:t>
            </a:r>
            <a:r>
              <a:rPr lang="en-US" sz="1000" baseline="-25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17, % of 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</a:t>
            </a:r>
            <a:r>
              <a:rPr lang="en-US" sz="1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RORgt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D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</a:t>
            </a:r>
            <a:r>
              <a:rPr lang="en-US" sz="1000" baseline="-25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17, % of 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IL-17A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E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regs, % of 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FOXP3 and CD25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F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</a:t>
            </a:r>
            <a:r>
              <a:rPr lang="en-US" sz="1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Tfh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, % of 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CXCR5 and BCL6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-</a:t>
            </a:r>
            <a:r>
              <a:rPr lang="en-US" sz="1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cytotox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, % of 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Granzyme A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-</a:t>
            </a:r>
            <a:r>
              <a:rPr lang="en-US" sz="1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cytotox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, % of 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Granzyme B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I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NF-alpha, % of 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TNF-alpha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J-Q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Number of cells/gram of tumor of the indicated 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 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T-cell populations present in </a:t>
            </a:r>
            <a:r>
              <a:rPr lang="en-US" sz="1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nail</a:t>
            </a:r>
            <a:r>
              <a:rPr lang="en-US" sz="1000" baseline="30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I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qM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and sgCD73 tumors before and after treatment with anti-CTLA4. Data represent pooled values from 3 independent experiments where n= 2-4 for each group. Bar graph data represent SEM, two-way ANOVA with Tukey’s multiple comparison test. All comparisons are not significant. </a:t>
            </a:r>
            <a:endParaRPr lang="en-US" sz="1000" dirty="0">
              <a:effectLst/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000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5354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22</TotalTime>
  <Words>354</Words>
  <Application>Microsoft Macintosh PowerPoint</Application>
  <PresentationFormat>Custom</PresentationFormat>
  <Paragraphs>5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ject #2</dc:title>
  <dc:creator>Microsoft Office User</dc:creator>
  <cp:lastModifiedBy>Anushka Dongre</cp:lastModifiedBy>
  <cp:revision>418</cp:revision>
  <dcterms:created xsi:type="dcterms:W3CDTF">2023-02-11T23:37:55Z</dcterms:created>
  <dcterms:modified xsi:type="dcterms:W3CDTF">2026-05-11T01:27:53Z</dcterms:modified>
</cp:coreProperties>
</file>